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ContentType="application/vnd.openxmlformats-officedocument.custom-properties+xml" PartName="/docProps/custom.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Relationship Id="rId5" Target="docProps/custom.xml" Type="http://schemas.openxmlformats.org/officeDocument/2006/relationships/custom-properties"/>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412" r:id="rId2"/>
    <p:sldId id="415" r:id="rId3"/>
    <p:sldId id="413" r:id="rId4"/>
  </p:sldIdLst>
  <p:sldSz cx="6858000" cy="12192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60" d="100"/>
          <a:sy n="60" d="100"/>
        </p:scale>
        <p:origin x="172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940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6885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741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4955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4914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3821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3493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9269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0730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8927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0524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2D576-4048-479B-A702-70ACBFD0F795}" type="datetimeFigureOut">
              <a:rPr lang="ko-KR" altLang="en-US" smtClean="0"/>
              <a:t>2025-10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ADF123-2EFB-42DD-BC14-826C11E1090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3210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DE048341-AECE-96E1-48D3-59D50CDBA90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832243" y="2489274"/>
          <a:ext cx="5059137" cy="400969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92693">
                  <a:extLst>
                    <a:ext uri="{9D8B030D-6E8A-4147-A177-3AD203B41FA5}">
                      <a16:colId xmlns:a16="http://schemas.microsoft.com/office/drawing/2014/main" val="2817213351"/>
                    </a:ext>
                  </a:extLst>
                </a:gridCol>
                <a:gridCol w="991611">
                  <a:extLst>
                    <a:ext uri="{9D8B030D-6E8A-4147-A177-3AD203B41FA5}">
                      <a16:colId xmlns:a16="http://schemas.microsoft.com/office/drawing/2014/main" val="2176677886"/>
                    </a:ext>
                  </a:extLst>
                </a:gridCol>
                <a:gridCol w="991611">
                  <a:extLst>
                    <a:ext uri="{9D8B030D-6E8A-4147-A177-3AD203B41FA5}">
                      <a16:colId xmlns:a16="http://schemas.microsoft.com/office/drawing/2014/main" val="3180624175"/>
                    </a:ext>
                  </a:extLst>
                </a:gridCol>
                <a:gridCol w="991611">
                  <a:extLst>
                    <a:ext uri="{9D8B030D-6E8A-4147-A177-3AD203B41FA5}">
                      <a16:colId xmlns:a16="http://schemas.microsoft.com/office/drawing/2014/main" val="3086836846"/>
                    </a:ext>
                  </a:extLst>
                </a:gridCol>
                <a:gridCol w="991611">
                  <a:extLst>
                    <a:ext uri="{9D8B030D-6E8A-4147-A177-3AD203B41FA5}">
                      <a16:colId xmlns:a16="http://schemas.microsoft.com/office/drawing/2014/main" val="722417698"/>
                    </a:ext>
                  </a:extLst>
                </a:gridCol>
              </a:tblGrid>
              <a:tr h="247568"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op 5 upregulated LncRNA genes</a:t>
                      </a:r>
                      <a:endParaRPr lang="ko-KR" altLang="ko-KR" sz="1000" b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5720" marR="55720" marT="27861" marB="27861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3509900"/>
                  </a:ext>
                </a:extLst>
              </a:tr>
              <a:tr h="247568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ko-KR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55720" marR="55720" marT="27861" marB="27861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marL="0" marR="0" lvl="0" indent="0" algn="ctr" defTabSz="685771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old change (p-value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85461892"/>
                  </a:ext>
                </a:extLst>
              </a:tr>
              <a:tr h="247568">
                <a:tc vMerge="1">
                  <a:txBody>
                    <a:bodyPr/>
                    <a:lstStyle/>
                    <a:p>
                      <a:pPr algn="l" latinLnBrk="1"/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ko-K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C827</a:t>
                      </a:r>
                      <a:endParaRPr lang="en-US" altLang="ko-KR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549</a:t>
                      </a:r>
                      <a:endParaRPr lang="en-US" altLang="ko-KR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ko-K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358</a:t>
                      </a:r>
                      <a:endParaRPr lang="en-US" altLang="ko-KR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292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72266445"/>
                  </a:ext>
                </a:extLst>
              </a:tr>
              <a:tr h="2475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nc-MTPAP-1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 (0.9414)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30 (0.0029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60 (0.0327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26 (0.0402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24299556"/>
                  </a:ext>
                </a:extLst>
              </a:tr>
              <a:tr h="2475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nc-PLXND1-1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69 (0.0207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19 (0.3499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40 (0.2894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42 (0.0177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45553876"/>
                  </a:ext>
                </a:extLst>
              </a:tr>
              <a:tr h="2475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nc-DHX40-1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89 (0.5813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96 (0.5727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93 (0.0911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05 (0.7255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29133922"/>
                  </a:ext>
                </a:extLst>
              </a:tr>
              <a:tr h="2475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HAP9-AS1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66 (0.0128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12 (0.0195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87 (0.0957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2.13 (0.0451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02469078"/>
                  </a:ext>
                </a:extLst>
              </a:tr>
              <a:tr h="2475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nc-USP28-1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0.70 (0.6063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31 (0.3780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1.12 (0.5824)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53831657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00" b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5720" marR="55720" marT="27861" marB="27861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5404539"/>
                  </a:ext>
                </a:extLst>
              </a:tr>
              <a:tr h="243503"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op 5 down regulated LncRNA genes</a:t>
                      </a:r>
                      <a:endParaRPr lang="ko-KR" altLang="ko-KR" sz="1000" b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5720" marR="55720" marT="27861" marB="27861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18619159"/>
                  </a:ext>
                </a:extLst>
              </a:tr>
              <a:tr h="243503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ko-KR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55720" marR="55720" marT="27861" marB="27861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old change (p-value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67365849"/>
                  </a:ext>
                </a:extLst>
              </a:tr>
              <a:tr h="243503">
                <a:tc vMerge="1">
                  <a:txBody>
                    <a:bodyPr/>
                    <a:lstStyle/>
                    <a:p>
                      <a:pPr algn="l" latinLnBrk="1"/>
                      <a:endParaRPr lang="ko-KR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ko-K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C827</a:t>
                      </a:r>
                      <a:endParaRPr lang="en-US" altLang="ko-KR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549</a:t>
                      </a:r>
                      <a:endParaRPr lang="en-US" altLang="ko-KR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altLang="ko-K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358</a:t>
                      </a:r>
                      <a:endParaRPr lang="en-US" altLang="ko-KR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292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561675024"/>
                  </a:ext>
                </a:extLst>
              </a:tr>
              <a:tr h="243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nc-TRA2A-1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2 (0.6021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6 (0.0020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3 (0.0148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8 (0.8360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6650578"/>
                  </a:ext>
                </a:extLst>
              </a:tr>
              <a:tr h="243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HID1-AS1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8 (0.2442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8 (0.9717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3 (0.3680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305537"/>
                  </a:ext>
                </a:extLst>
              </a:tr>
              <a:tr h="243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IR200CHG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9 (0.9098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25 (0.0358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45 (0.0001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2 (0.0002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6700191"/>
                  </a:ext>
                </a:extLst>
              </a:tr>
              <a:tr h="243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nc-PBX1-2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3 (0.1670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7 (0.0043)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394632"/>
                  </a:ext>
                </a:extLst>
              </a:tr>
              <a:tr h="243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OC101929217</a:t>
                      </a:r>
                    </a:p>
                  </a:txBody>
                  <a:tcPr marL="5805" marR="5805" marT="5805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5805" marR="5805" marT="580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5679751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B537396-8433-3E52-8022-B733B7E5CB1A}"/>
              </a:ext>
            </a:extLst>
          </p:cNvPr>
          <p:cNvSpPr txBox="1"/>
          <p:nvPr/>
        </p:nvSpPr>
        <p:spPr>
          <a:xfrm>
            <a:off x="832242" y="6664061"/>
            <a:ext cx="5059136" cy="14427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371475"/>
            <a:r>
              <a:rPr lang="en-US" altLang="ko-KR" sz="975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upplement Table 1</a:t>
            </a:r>
            <a:r>
              <a:rPr lang="en-US" altLang="ko-KR" sz="975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 </a:t>
            </a:r>
            <a:r>
              <a:rPr lang="en-US" altLang="ko-KR" sz="975" b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qRT</a:t>
            </a:r>
            <a:r>
              <a:rPr lang="en-US" altLang="ko-KR" sz="975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PCR Validation of Top 10 Differentially Expressed </a:t>
            </a:r>
            <a:r>
              <a:rPr lang="en-US" altLang="ko-KR" sz="975" b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lncRNAs</a:t>
            </a:r>
            <a:r>
              <a:rPr lang="en-US" altLang="ko-KR" sz="975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(Upregulated and Downregulated) Between PM10-Exposed and Control Groups</a:t>
            </a:r>
            <a:r>
              <a:rPr lang="en-US" altLang="ko-KR" sz="975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</a:p>
          <a:p>
            <a:pPr defTabSz="371475"/>
            <a:r>
              <a:rPr lang="en-US" altLang="ko-KR" sz="975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xpression changes were validated by PCR for selected </a:t>
            </a:r>
            <a:r>
              <a:rPr lang="en-US" altLang="ko-KR" sz="975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lncRNAs</a:t>
            </a:r>
            <a:r>
              <a:rPr lang="en-US" altLang="ko-KR" sz="975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identified from Agilent microarray analysis. Among the ten tested candidates, only lnc-MTPAP-1 exhibited consistent expression patterns between microarray and PCR results, whereas the remaining nine </a:t>
            </a:r>
            <a:r>
              <a:rPr lang="en-US" altLang="ko-KR" sz="975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lncRNAs</a:t>
            </a:r>
            <a:r>
              <a:rPr lang="en-US" altLang="ko-KR" sz="975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showed inconsistent results. </a:t>
            </a:r>
            <a:r>
              <a:rPr lang="en-US" altLang="ko-KR" sz="975" dirty="0">
                <a:solidFill>
                  <a:srgbClr val="1F1F1F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While most </a:t>
            </a:r>
            <a:r>
              <a:rPr lang="en-US" altLang="ko-KR" sz="975" dirty="0" err="1">
                <a:solidFill>
                  <a:srgbClr val="1F1F1F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lncRNAs</a:t>
            </a:r>
            <a:r>
              <a:rPr lang="en-US" altLang="ko-KR" sz="975" dirty="0">
                <a:solidFill>
                  <a:srgbClr val="1F1F1F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yielded qPCR results, some lncRNA–cell line combinations failed to produce detectable signals, possibly due to low expression levels or technical limitation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75DAABC-2A48-4CBF-8C9C-596A47C654B6}"/>
              </a:ext>
            </a:extLst>
          </p:cNvPr>
          <p:cNvSpPr txBox="1"/>
          <p:nvPr/>
        </p:nvSpPr>
        <p:spPr>
          <a:xfrm>
            <a:off x="140677" y="1343492"/>
            <a:ext cx="6576647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Data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ko-KR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076156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F4EA5ECA-7725-4F25-B57F-2C55AF7E96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7741412"/>
              </p:ext>
            </p:extLst>
          </p:nvPr>
        </p:nvGraphicFramePr>
        <p:xfrm>
          <a:off x="290647" y="2113265"/>
          <a:ext cx="6276704" cy="7391967"/>
        </p:xfrm>
        <a:graphic>
          <a:graphicData uri="http://schemas.openxmlformats.org/drawingml/2006/table">
            <a:tbl>
              <a:tblPr firstRow="1" firstCol="1" bandRow="1"/>
              <a:tblGrid>
                <a:gridCol w="1221735">
                  <a:extLst>
                    <a:ext uri="{9D8B030D-6E8A-4147-A177-3AD203B41FA5}">
                      <a16:colId xmlns:a16="http://schemas.microsoft.com/office/drawing/2014/main" val="309288179"/>
                    </a:ext>
                  </a:extLst>
                </a:gridCol>
                <a:gridCol w="2178197">
                  <a:extLst>
                    <a:ext uri="{9D8B030D-6E8A-4147-A177-3AD203B41FA5}">
                      <a16:colId xmlns:a16="http://schemas.microsoft.com/office/drawing/2014/main" val="443190358"/>
                    </a:ext>
                  </a:extLst>
                </a:gridCol>
                <a:gridCol w="1394071">
                  <a:extLst>
                    <a:ext uri="{9D8B030D-6E8A-4147-A177-3AD203B41FA5}">
                      <a16:colId xmlns:a16="http://schemas.microsoft.com/office/drawing/2014/main" val="3500672894"/>
                    </a:ext>
                  </a:extLst>
                </a:gridCol>
                <a:gridCol w="1482701">
                  <a:extLst>
                    <a:ext uri="{9D8B030D-6E8A-4147-A177-3AD203B41FA5}">
                      <a16:colId xmlns:a16="http://schemas.microsoft.com/office/drawing/2014/main" val="3965616753"/>
                    </a:ext>
                  </a:extLst>
                </a:gridCol>
              </a:tblGrid>
              <a:tr h="173164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embl ID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otein name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olecular function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iologic function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295624"/>
                  </a:ext>
                </a:extLst>
              </a:tr>
              <a:tr h="966847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P00000401371</a:t>
                      </a:r>
                      <a:endParaRPr lang="ko-KR" sz="9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ytotoxic granule associated RNA binding protein TIA1</a:t>
                      </a: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 Nucleolysin TIA-1 isoform p40, RNA-binding protein TIA-1, T-cell-restricted intracellular antigen-1, TIA-1, p40-TIA-1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NA bind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poptosis, mRNAprocessing,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RNA splic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9489196"/>
                  </a:ext>
                </a:extLst>
              </a:tr>
              <a:tr h="549698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P00000290341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Insulin-like growth factor 2 mRNA-binding protein 1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NA bind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RNA transport.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ansulation regulation,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ansport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7093519"/>
                  </a:ext>
                </a:extLst>
              </a:tr>
              <a:tr h="817143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P00000258729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nsulin-like growth factor 2 mRNA-binding protein 3</a:t>
                      </a: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 IGF2 mRNA-binding protein 3, IMP-3, IGF-II mRNA-binding protein 3, KH domain-containing protein overexpressed in cancer, hKOC, VICKZ family member 3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NA bind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RNA transport.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ansulation regulation,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ansport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9805507"/>
                  </a:ext>
                </a:extLst>
              </a:tr>
              <a:tr h="966847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P00000371634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nsulin-like growth factor 2 mRNA-binding protein 2</a:t>
                      </a: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 IGF2 mRNA-binding protein 2, IMP-2, Hepatocellular carcinoma autoantigen p62, IGF-II mRNA-binding protein 2, VICKZ family member 2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NA bind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RNA transport.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ansulation regulation,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ansport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9734970"/>
                  </a:ext>
                </a:extLst>
              </a:tr>
              <a:tr h="9291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P00000220592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otein argonaute-2</a:t>
                      </a: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 Argonaute2, hAgo2, 3.1.26.n2, Argonaute RISC catalytic component 2, Eukaryotic translation initiation factor 2C 2, eIF-2C 2, eIF2C 2, PAZ Piwi domain protein, PPD, Protein slicer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donuclease, hydrolase, Nuclease, Repressor, Ribonucleoprotein, RNA-binding</a:t>
                      </a:r>
                      <a:endParaRPr lang="ko-KR" sz="9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ost-virus interaction, RNA-meidated gene silencing, transcription, transcription regulation, translation regulation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5890263"/>
                  </a:ext>
                </a:extLst>
              </a:tr>
              <a:tr h="737965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P00000240185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AR DNA-binding protein 43</a:t>
                      </a: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 TDP-43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NA binding, Repressor, RNA bind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iological rhythms, mRNA processing, mRNA splicing, Transcription, Transcription regulation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8597380"/>
                  </a:ext>
                </a:extLst>
              </a:tr>
              <a:tr h="627996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P00000381031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NA-binding protein EWS</a:t>
                      </a: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 EWS oncogene, Ewing sarcoma breakpoint region 1 protein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lmodulin-binding, Repressor, RNA-bind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ranscription, transcription regulation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948484"/>
                  </a:ext>
                </a:extLst>
              </a:tr>
              <a:tr h="666559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. ENSP00000349428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olypyrimidine tract-binding protein 1</a:t>
                      </a: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 PTB, 57 kDa RNA-binding protein PPTB-1, Heterogeneous nuclear ribonucleoprotein I, hnRNP I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ctivator, Repressor, RNA- bind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RNA processing, mRNA splic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6782979"/>
                  </a:ext>
                </a:extLst>
              </a:tr>
              <a:tr h="327707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P00000385269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LAV-like protein 1</a:t>
                      </a: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 Hu-antigen R, HuR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NA- bind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5746461"/>
                  </a:ext>
                </a:extLst>
              </a:tr>
              <a:tr h="628876"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SP00000254108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NA-binding protein FUS</a:t>
                      </a:r>
                      <a:r>
                        <a:rPr lang="en-US" sz="700" kern="100">
                          <a:solidFill>
                            <a:srgbClr val="0A0A0A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, 75 kDa DNA-pairing protein, Oncogene FUS, Oncogene TLS, POMp75, Translocated in liposarcoma protein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NA-binding, RNA binding</a:t>
                      </a:r>
                      <a:endParaRPr lang="ko-KR" sz="9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 </a:t>
                      </a:r>
                      <a:endParaRPr lang="ko-KR" sz="9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642" marR="626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4466008"/>
                  </a:ext>
                </a:extLst>
              </a:tr>
            </a:tbl>
          </a:graphicData>
        </a:graphic>
      </p:graphicFrame>
      <p:sp>
        <p:nvSpPr>
          <p:cNvPr id="3" name="직사각형 2">
            <a:extLst>
              <a:ext uri="{FF2B5EF4-FFF2-40B4-BE49-F238E27FC236}">
                <a16:creationId xmlns:a16="http://schemas.microsoft.com/office/drawing/2014/main" id="{6F177721-830E-47CC-97EE-E46A9DB0E4B9}"/>
              </a:ext>
            </a:extLst>
          </p:cNvPr>
          <p:cNvSpPr/>
          <p:nvPr/>
        </p:nvSpPr>
        <p:spPr>
          <a:xfrm>
            <a:off x="290649" y="1422273"/>
            <a:ext cx="638447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altLang="ko-K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 Table 2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List of proteins predicted to interact with lncRNA MTPAP-1</a:t>
            </a:r>
          </a:p>
          <a:p>
            <a:br>
              <a:rPr lang="en-US" altLang="ko-KR" dirty="0"/>
            </a:b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04396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그림 1">
            <a:extLst>
              <a:ext uri="{FF2B5EF4-FFF2-40B4-BE49-F238E27FC236}">
                <a16:creationId xmlns:a16="http://schemas.microsoft.com/office/drawing/2014/main" id="{1B4B2580-F9E8-4FFE-BACE-B5269987141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367" y="2394757"/>
            <a:ext cx="5831337" cy="27606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88EEB7A-FCC5-4B8F-90ED-AE04880EFA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677" y="7900300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316B0A2-B035-46DA-B9F9-A9A487FFB897}"/>
              </a:ext>
            </a:extLst>
          </p:cNvPr>
          <p:cNvSpPr txBox="1"/>
          <p:nvPr/>
        </p:nvSpPr>
        <p:spPr>
          <a:xfrm>
            <a:off x="140677" y="1343492"/>
            <a:ext cx="6576647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Data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ko-KR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4D7D520B-F114-420F-B5A4-3E1EBECB6F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7367" y="5309810"/>
            <a:ext cx="5831336" cy="5190431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7A85D8B7-2854-4A7E-B1BC-C723EBE2C434}"/>
              </a:ext>
            </a:extLst>
          </p:cNvPr>
          <p:cNvSpPr/>
          <p:nvPr/>
        </p:nvSpPr>
        <p:spPr>
          <a:xfrm>
            <a:off x="140676" y="1820305"/>
            <a:ext cx="602601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 Table 3. </a:t>
            </a:r>
            <a:r>
              <a:rPr lang="en-US" altLang="ko-KR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</a:t>
            </a:r>
            <a:r>
              <a:rPr lang="en-US" altLang="ko-KR" sz="1200" b="1" baseline="-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mposition from the sheet of certificate/product information sheet of  ERM® CZ120</a:t>
            </a:r>
          </a:p>
        </p:txBody>
      </p:sp>
    </p:spTree>
    <p:extLst>
      <p:ext uri="{BB962C8B-B14F-4D97-AF65-F5344CB8AC3E}">
        <p14:creationId xmlns:p14="http://schemas.microsoft.com/office/powerpoint/2010/main" val="1638561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67</Words>
  <Application>Microsoft Office PowerPoint</Application>
  <PresentationFormat>와이드스크린</PresentationFormat>
  <Paragraphs>133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0" baseType="lpstr">
      <vt:lpstr>굴림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mc</dc:creator>
  <cp:lastModifiedBy>cmc</cp:lastModifiedBy>
  <cp:revision>1</cp:revision>
  <dcterms:created xsi:type="dcterms:W3CDTF">2025-10-13T11:37:30Z</dcterms:created>
  <dcterms:modified xsi:type="dcterms:W3CDTF">2025-10-13T11:40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name="Fasoo_Trace_ID" pid="2">
    <vt:lpwstr>eyJub2RlMSI6eyJkc2QiOiIwMTAwMDAwMDAwMDAzMTk0IiwibG9nVGltZSI6IjIwMjUtMTAtMTNUMTE6NDA6MThaIiwicElEIjoxLCJwcm9jZXNzSWQiOjU2MjAsInByb2Nlc3NOYW1lIjoiUE9XRVJQTlQuRVhFIiwidHJhY2VJZCI6IjFEOTc5N0I5RjlFMzRGMjhBMTg1QTJEQThCNkJBMEQ0IiwidXNlckNvZGUiOiIyMTEwMDg4OSJ9LCJub2RlMiI6eyJkc2QiOiIwMTAwMDAwMDAwMDAzMTk0IiwibG9nVGltZSI6IjIwMjUtMTAtMTNUMTE6NDA6MThaIiwicElEIjoxLCJwcm9jZXNzSWQiOjU2MjAsInByb2Nlc3NOYW1lIjoiUE9XRVJQTlQuRVhFIiwidHJhY2VJZCI6IjFEOTc5N0I5RjlFMzRGMjhBMTg1QTJEQThCNkJBMEQ0IiwidXNlckNvZGUiOiIyMTEwMDg4OSJ9LCJub2RlMyI6eyJkc2QiOiIwMTAwMDAwMDAwMDAzMTk0IiwibG9nVGltZSI6IjIwMjUtMTAtMTNUMTE6NDA6MThaIiwicElEIjoxLCJwcm9jZXNzSWQiOjU2MjAsInByb2Nlc3NOYW1lIjoiUE9XRVJQTlQuRVhFIiwidHJhY2VJZCI6IjFEOTc5N0I5RjlFMzRGMjhBMTg1QTJEQThCNkJBMEQ0IiwidXNlckNvZGUiOiIyMTEwMDg4OSJ9LCJub2RlNCI6eyJkc2QiOiIwMTAwMDAwMDAwMDAzMTk0IiwibG9nVGltZSI6IjIwMjUtMTAtMTNUMTE6NDA6MThaIiwicElEIjoxLCJwcm9jZXNzSWQiOjU2MjAsInByb2Nlc3NOYW1lIjoiUE9XRVJQTlQuRVhFIiwidHJhY2VJZCI6IjFEOTc5N0I5RjlFMzRGMjhBMTg1QTJEQThCNkJBMEQ0IiwidXNlckNvZGUiOiIyMTEwMDg4OSJ9LCJub2RlNSI6eyJkc2QiOiIwMDAwMDAwMDAwMDAwMDAwIiwibG9nVGltZSI6IjIwMjUtMTAtMTNUMTI6MTE6MTdaIiwicElEIjoyMDQ4LCJwcm9jZXNzSWQiOjU2MjAsInByb2Nlc3NOYW1lIjoiUE9XRVJQTlQuRVhFIiwidHJhY2VJZCI6IjZFRTE2MkNBQzc3MDREMkI5MUVEMTYyMUZFRjc1MUMzIiwidXNlckNvZGUiOiIyMTEwMDg4OSJ9LCJub2RlQ291bnQiOjIsInJvb3RUcmFjZUlkIjoiMUQ5Nzk3QjlGOUUzNEYyOEExODVBMkRBOEI2QkEwRDQifQ==</vt:lpwstr>
  </property>
</Properties>
</file>